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9"/>
  </p:notesMasterIdLst>
  <p:sldIdLst>
    <p:sldId id="640" r:id="rId2"/>
    <p:sldId id="811" r:id="rId3"/>
    <p:sldId id="812" r:id="rId4"/>
    <p:sldId id="822" r:id="rId5"/>
    <p:sldId id="813" r:id="rId6"/>
    <p:sldId id="823" r:id="rId7"/>
    <p:sldId id="809" r:id="rId8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204" autoAdjust="0"/>
    <p:restoredTop sz="92607" autoAdjust="0"/>
  </p:normalViewPr>
  <p:slideViewPr>
    <p:cSldViewPr snapToGrid="0">
      <p:cViewPr varScale="1">
        <p:scale>
          <a:sx n="115" d="100"/>
          <a:sy n="115" d="100"/>
        </p:scale>
        <p:origin x="1829" y="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24434E5-0359-469D-B70C-24235987D031}" type="datetimeFigureOut">
              <a:rPr lang="zh-CN" altLang="en-US" smtClean="0"/>
              <a:t>2023/02/0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A8ACC6C-6650-4CC0-BA82-E2C070CFE4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690936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A8ACC6C-6650-4CC0-BA82-E2C070CFE445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338194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A8ACC6C-6650-4CC0-BA82-E2C070CFE445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503479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A8ACC6C-6650-4CC0-BA82-E2C070CFE445}" type="slidenum">
              <a:rPr lang="zh-CN" altLang="en-US" smtClean="0"/>
              <a:t>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974275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A8ACC6C-6650-4CC0-BA82-E2C070CFE445}" type="slidenum">
              <a:rPr lang="zh-CN" altLang="en-US" smtClean="0"/>
              <a:t>7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2588647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B788E-4814-4982-B93C-2B8B8B2DCBD3}" type="datetimeFigureOut">
              <a:rPr lang="zh-CN" altLang="en-US" smtClean="0"/>
              <a:t>2023/02/0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49F019-C334-456D-8937-DDF3D45B64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183934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B788E-4814-4982-B93C-2B8B8B2DCBD3}" type="datetimeFigureOut">
              <a:rPr lang="zh-CN" altLang="en-US" smtClean="0"/>
              <a:t>2023/02/0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49F019-C334-456D-8937-DDF3D45B64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303997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B788E-4814-4982-B93C-2B8B8B2DCBD3}" type="datetimeFigureOut">
              <a:rPr lang="zh-CN" altLang="en-US" smtClean="0"/>
              <a:t>2023/02/0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49F019-C334-456D-8937-DDF3D45B64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46157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B788E-4814-4982-B93C-2B8B8B2DCBD3}" type="datetimeFigureOut">
              <a:rPr lang="zh-CN" altLang="en-US" smtClean="0"/>
              <a:t>2023/02/0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49F019-C334-456D-8937-DDF3D45B64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52936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B788E-4814-4982-B93C-2B8B8B2DCBD3}" type="datetimeFigureOut">
              <a:rPr lang="zh-CN" altLang="en-US" smtClean="0"/>
              <a:t>2023/02/0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49F019-C334-456D-8937-DDF3D45B64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26389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B788E-4814-4982-B93C-2B8B8B2DCBD3}" type="datetimeFigureOut">
              <a:rPr lang="zh-CN" altLang="en-US" smtClean="0"/>
              <a:t>2023/02/0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49F019-C334-456D-8937-DDF3D45B64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2835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B788E-4814-4982-B93C-2B8B8B2DCBD3}" type="datetimeFigureOut">
              <a:rPr lang="zh-CN" altLang="en-US" smtClean="0"/>
              <a:t>2023/02/0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49F019-C334-456D-8937-DDF3D45B64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515824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B788E-4814-4982-B93C-2B8B8B2DCBD3}" type="datetimeFigureOut">
              <a:rPr lang="zh-CN" altLang="en-US" smtClean="0"/>
              <a:t>2023/02/0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49F019-C334-456D-8937-DDF3D45B64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416510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B788E-4814-4982-B93C-2B8B8B2DCBD3}" type="datetimeFigureOut">
              <a:rPr lang="zh-CN" altLang="en-US" smtClean="0"/>
              <a:t>2023/02/0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49F019-C334-456D-8937-DDF3D45B64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38093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B788E-4814-4982-B93C-2B8B8B2DCBD3}" type="datetimeFigureOut">
              <a:rPr lang="zh-CN" altLang="en-US" smtClean="0"/>
              <a:t>2023/02/0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49F019-C334-456D-8937-DDF3D45B64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43878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B788E-4814-4982-B93C-2B8B8B2DCBD3}" type="datetimeFigureOut">
              <a:rPr lang="zh-CN" altLang="en-US" smtClean="0"/>
              <a:t>2023/02/0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49F019-C334-456D-8937-DDF3D45B64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5648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BB788E-4814-4982-B93C-2B8B8B2DCBD3}" type="datetimeFigureOut">
              <a:rPr lang="zh-CN" altLang="en-US" smtClean="0"/>
              <a:t>2023/02/0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49F019-C334-456D-8937-DDF3D45B64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34353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格 2">
            <a:extLst>
              <a:ext uri="{FF2B5EF4-FFF2-40B4-BE49-F238E27FC236}">
                <a16:creationId xmlns:a16="http://schemas.microsoft.com/office/drawing/2014/main" id="{01420707-C293-4C75-B60F-F07284E6C59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72371004"/>
              </p:ext>
            </p:extLst>
          </p:nvPr>
        </p:nvGraphicFramePr>
        <p:xfrm>
          <a:off x="411986" y="2182686"/>
          <a:ext cx="8320028" cy="2952330"/>
        </p:xfrm>
        <a:graphic>
          <a:graphicData uri="http://schemas.openxmlformats.org/drawingml/2006/table">
            <a:tbl>
              <a:tblPr firstRow="1" firstCol="1" bandRow="1"/>
              <a:tblGrid>
                <a:gridCol w="2044470">
                  <a:extLst>
                    <a:ext uri="{9D8B030D-6E8A-4147-A177-3AD203B41FA5}">
                      <a16:colId xmlns:a16="http://schemas.microsoft.com/office/drawing/2014/main" val="2099801647"/>
                    </a:ext>
                  </a:extLst>
                </a:gridCol>
                <a:gridCol w="648247">
                  <a:extLst>
                    <a:ext uri="{9D8B030D-6E8A-4147-A177-3AD203B41FA5}">
                      <a16:colId xmlns:a16="http://schemas.microsoft.com/office/drawing/2014/main" val="1844443331"/>
                    </a:ext>
                  </a:extLst>
                </a:gridCol>
                <a:gridCol w="941436">
                  <a:extLst>
                    <a:ext uri="{9D8B030D-6E8A-4147-A177-3AD203B41FA5}">
                      <a16:colId xmlns:a16="http://schemas.microsoft.com/office/drawing/2014/main" val="605950331"/>
                    </a:ext>
                  </a:extLst>
                </a:gridCol>
                <a:gridCol w="961293">
                  <a:extLst>
                    <a:ext uri="{9D8B030D-6E8A-4147-A177-3AD203B41FA5}">
                      <a16:colId xmlns:a16="http://schemas.microsoft.com/office/drawing/2014/main" val="4231668672"/>
                    </a:ext>
                  </a:extLst>
                </a:gridCol>
                <a:gridCol w="1781907">
                  <a:extLst>
                    <a:ext uri="{9D8B030D-6E8A-4147-A177-3AD203B41FA5}">
                      <a16:colId xmlns:a16="http://schemas.microsoft.com/office/drawing/2014/main" val="2085291697"/>
                    </a:ext>
                  </a:extLst>
                </a:gridCol>
                <a:gridCol w="1942675">
                  <a:extLst>
                    <a:ext uri="{9D8B030D-6E8A-4147-A177-3AD203B41FA5}">
                      <a16:colId xmlns:a16="http://schemas.microsoft.com/office/drawing/2014/main" val="3048229310"/>
                    </a:ext>
                  </a:extLst>
                </a:gridCol>
              </a:tblGrid>
              <a:tr h="590466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arents</a:t>
                      </a:r>
                      <a:endParaRPr lang="zh-CN" sz="14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ode</a:t>
                      </a:r>
                      <a:endParaRPr lang="zh-CN" sz="14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ID</a:t>
                      </a:r>
                      <a:endParaRPr lang="zh-CN" sz="14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Origin</a:t>
                      </a:r>
                      <a:endParaRPr lang="zh-CN" sz="14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gronomic relevance</a:t>
                      </a:r>
                      <a:endParaRPr lang="zh-CN" sz="14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esistance relevance</a:t>
                      </a:r>
                      <a:endParaRPr lang="zh-CN" sz="14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01116691"/>
                  </a:ext>
                </a:extLst>
              </a:tr>
              <a:tr h="590466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AGC-08</a:t>
                      </a:r>
                      <a:endParaRPr lang="zh-CN" sz="14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</a:t>
                      </a:r>
                      <a:endParaRPr lang="zh-CN" sz="14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14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301214</a:t>
                      </a:r>
                      <a:endParaRPr lang="zh-CN" altLang="en-US" sz="1400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hina</a:t>
                      </a:r>
                      <a:endParaRPr lang="zh-CN" sz="14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hort grain, thickness stem</a:t>
                      </a:r>
                      <a:endParaRPr lang="zh-CN" sz="14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e, Al, salt, Cd, drought tolerance</a:t>
                      </a:r>
                      <a:endParaRPr lang="zh-CN" sz="14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57636891"/>
                  </a:ext>
                </a:extLst>
              </a:tr>
              <a:tr h="590466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HHZ 5-SAL 9-Y 3-Y 1</a:t>
                      </a:r>
                      <a:endParaRPr lang="zh-CN" sz="14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B</a:t>
                      </a:r>
                      <a:endParaRPr lang="zh-CN" sz="14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857043</a:t>
                      </a:r>
                      <a:endParaRPr lang="zh-CN" sz="14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IRRI-GSR</a:t>
                      </a:r>
                      <a:endParaRPr lang="zh-CN" sz="14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Long grain, good grain quality</a:t>
                      </a:r>
                      <a:endParaRPr lang="zh-CN" sz="14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e tolerance</a:t>
                      </a:r>
                      <a:endParaRPr lang="zh-CN" sz="14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45311505"/>
                  </a:ext>
                </a:extLst>
              </a:tr>
              <a:tr h="590466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BP1976B-2-3-7-TB-1-1</a:t>
                      </a:r>
                      <a:endParaRPr lang="zh-CN" sz="14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</a:t>
                      </a:r>
                      <a:endParaRPr lang="zh-CN" sz="14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300964</a:t>
                      </a:r>
                      <a:endParaRPr lang="zh-CN" sz="14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Indonesia</a:t>
                      </a:r>
                      <a:endParaRPr lang="zh-CN" sz="14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Long grain</a:t>
                      </a:r>
                      <a:endParaRPr lang="zh-CN" sz="14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Zn tolerance, blast disease resistance</a:t>
                      </a:r>
                      <a:endParaRPr lang="zh-CN" sz="14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04095372"/>
                  </a:ext>
                </a:extLst>
              </a:tr>
              <a:tr h="590466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R 33282-B-8-1-1-1-1-1</a:t>
                      </a:r>
                      <a:endParaRPr lang="zh-CN" sz="14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D</a:t>
                      </a:r>
                      <a:endParaRPr lang="zh-CN" sz="14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752173</a:t>
                      </a:r>
                      <a:endParaRPr lang="zh-CN" sz="14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hil Rice</a:t>
                      </a:r>
                      <a:endParaRPr lang="zh-CN" sz="14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Long grain, high yielding</a:t>
                      </a:r>
                      <a:endParaRPr lang="zh-CN" sz="14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l tolerance, bacterial blight resistance</a:t>
                      </a:r>
                      <a:endParaRPr lang="zh-CN" sz="14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34325921"/>
                  </a:ext>
                </a:extLst>
              </a:tr>
            </a:tbl>
          </a:graphicData>
        </a:graphic>
      </p:graphicFrame>
      <p:sp>
        <p:nvSpPr>
          <p:cNvPr id="4" name="Text Box 3">
            <a:extLst>
              <a:ext uri="{FF2B5EF4-FFF2-40B4-BE49-F238E27FC236}">
                <a16:creationId xmlns:a16="http://schemas.microsoft.com/office/drawing/2014/main" id="{AF139C33-27C9-43C2-AAC9-FCE117A0672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52992" y="756899"/>
            <a:ext cx="6821990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pPr algn="ctr"/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sym typeface="黑体" panose="02010609060101010101" pitchFamily="49" charset="-122"/>
              </a:rPr>
              <a:t>Table S1. Description of the four parental lines used for developing the MAGIC DC1 population</a:t>
            </a:r>
            <a:endParaRPr lang="zh-CN" altLang="en-US" b="1" dirty="0">
              <a:solidFill>
                <a:srgbClr val="FF0000"/>
              </a:solidFill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464912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122170">
            <a:extLst>
              <a:ext uri="{FF2B5EF4-FFF2-40B4-BE49-F238E27FC236}">
                <a16:creationId xmlns:a16="http://schemas.microsoft.com/office/drawing/2014/main" id="{183F1A3C-7191-4434-971B-1E0752DC4CD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17314" y="986115"/>
            <a:ext cx="3938771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pPr algn="ctr"/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</a:rPr>
              <a:t>Table S2. Primers used for </a:t>
            </a:r>
            <a:r>
              <a:rPr lang="en-US" altLang="zh-CN" b="1" dirty="0" err="1">
                <a:latin typeface="Times New Roman" panose="02020603050405020304" pitchFamily="18" charset="0"/>
                <a:ea typeface="黑体" panose="02010609060101010101" pitchFamily="49" charset="-122"/>
              </a:rPr>
              <a:t>qRT</a:t>
            </a:r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</a:rPr>
              <a:t>-PCR </a:t>
            </a:r>
          </a:p>
        </p:txBody>
      </p:sp>
      <p:graphicFrame>
        <p:nvGraphicFramePr>
          <p:cNvPr id="6" name="表格 5">
            <a:extLst>
              <a:ext uri="{FF2B5EF4-FFF2-40B4-BE49-F238E27FC236}">
                <a16:creationId xmlns:a16="http://schemas.microsoft.com/office/drawing/2014/main" id="{AEBC9AAE-ECCC-47B3-A3A2-C9BFCED07BB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21929267"/>
              </p:ext>
            </p:extLst>
          </p:nvPr>
        </p:nvGraphicFramePr>
        <p:xfrm>
          <a:off x="786581" y="2099597"/>
          <a:ext cx="7570838" cy="397764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862872">
                  <a:extLst>
                    <a:ext uri="{9D8B030D-6E8A-4147-A177-3AD203B41FA5}">
                      <a16:colId xmlns:a16="http://schemas.microsoft.com/office/drawing/2014/main" val="2021791445"/>
                    </a:ext>
                  </a:extLst>
                </a:gridCol>
                <a:gridCol w="2974383">
                  <a:extLst>
                    <a:ext uri="{9D8B030D-6E8A-4147-A177-3AD203B41FA5}">
                      <a16:colId xmlns:a16="http://schemas.microsoft.com/office/drawing/2014/main" val="1331961596"/>
                    </a:ext>
                  </a:extLst>
                </a:gridCol>
                <a:gridCol w="2733583">
                  <a:extLst>
                    <a:ext uri="{9D8B030D-6E8A-4147-A177-3AD203B41FA5}">
                      <a16:colId xmlns:a16="http://schemas.microsoft.com/office/drawing/2014/main" val="2302445281"/>
                    </a:ext>
                  </a:extLst>
                </a:gridCol>
              </a:tblGrid>
              <a:tr h="21874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</a:t>
                      </a:r>
                      <a:r>
                        <a:rPr lang="en-US" altLang="zh-C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es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Reverse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39269289"/>
                  </a:ext>
                </a:extLst>
              </a:tr>
              <a:tr h="21874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sActin (NM_197297) 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ACACCCCTGCTATGTACG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CACCAGAGTCCAACACAA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27251743"/>
                  </a:ext>
                </a:extLst>
              </a:tr>
              <a:tr h="21874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C_Os03g0350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AGGAGCCGGAGAAGAAGA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CTTGCCGTCACCTTCCTT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57351489"/>
                  </a:ext>
                </a:extLst>
              </a:tr>
              <a:tr h="21874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C_Os03g0355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TGACAACCGAAGTCCAAC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CTGCTGCAGTTGAAACAT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10854161"/>
                  </a:ext>
                </a:extLst>
              </a:tr>
              <a:tr h="21874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C_Os03g0359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GTGCTTCGCATCTTCATCT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AAGGTGCATTACCACAGG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77294596"/>
                  </a:ext>
                </a:extLst>
              </a:tr>
              <a:tr h="21874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C_Os03g0366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CCAGTTTGGCACAACTTA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CCTTGGTGATGAGCTTGC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18442784"/>
                  </a:ext>
                </a:extLst>
              </a:tr>
              <a:tr h="21874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C_Os03g0368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TCGACAACAACAGCGGAT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TGGCTGCATTGTCCCATC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38770858"/>
                  </a:ext>
                </a:extLst>
              </a:tr>
              <a:tr h="21874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C_Os03g0370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TCCTCACTGTGGCACAAAC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TATCTTGCCCTGCCTTGC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68181796"/>
                  </a:ext>
                </a:extLst>
              </a:tr>
              <a:tr h="21874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C_Os03g0376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ACAGGTGCAACAGGTGGA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CAAGGGACATCACACTCA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76011718"/>
                  </a:ext>
                </a:extLst>
              </a:tr>
              <a:tr h="21874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C_Os03g0383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CTGTTCCTCAGTTGGAG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GGTGCCTCTCCATCAAAT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08352673"/>
                  </a:ext>
                </a:extLst>
              </a:tr>
              <a:tr h="21874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C_Os03g03949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TCTGGAGACCGCCTACC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ATATGCCACCAGACCAA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6853207"/>
                  </a:ext>
                </a:extLst>
              </a:tr>
              <a:tr h="21874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C_Os03g0436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CTGCTTCTTCCGCTTCTG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CGCGTACTCCGACATGAT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3807168"/>
                  </a:ext>
                </a:extLst>
              </a:tr>
              <a:tr h="21874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C_Os03g0443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GCAATGGTCCTTGAAGCC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GAACAGCACGCGAATCTC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37934678"/>
                  </a:ext>
                </a:extLst>
              </a:tr>
              <a:tr h="21874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C_Os03g0448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TCGCCCTAGAAGCAGTGT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GCGCTCAAGATTCCTAGTG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14957365"/>
                  </a:ext>
                </a:extLst>
              </a:tr>
              <a:tr h="21874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C_Os03g0449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AACAGCAACATCAGGCTT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GTCCATTCGTACCGTCCA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81685337"/>
                  </a:ext>
                </a:extLst>
              </a:tr>
              <a:tr h="21874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C_Os03g0457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CAAGGTGATCCCTCTGCT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GCCCTGCTTCACGAATAG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32069895"/>
                  </a:ext>
                </a:extLst>
              </a:tr>
              <a:tr h="21874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C_Os03g0489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GAGGTTGAGCGTGAATGG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TGACACGGCCTGAGAGAA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2000860"/>
                  </a:ext>
                </a:extLst>
              </a:tr>
              <a:tr h="21874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C_Os03g0529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CGCCATCGGCTTCATC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GTACACCCACTGGGACTC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9613098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619930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83971">
            <a:extLst>
              <a:ext uri="{FF2B5EF4-FFF2-40B4-BE49-F238E27FC236}">
                <a16:creationId xmlns:a16="http://schemas.microsoft.com/office/drawing/2014/main" id="{984B77BB-E4F8-40F4-ACC3-6BFC135A44B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0315" y="1267743"/>
            <a:ext cx="7703369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3. Primers used to amplify the open reading frame of candidate genes</a:t>
            </a:r>
          </a:p>
        </p:txBody>
      </p:sp>
      <p:graphicFrame>
        <p:nvGraphicFramePr>
          <p:cNvPr id="5" name="表格 4">
            <a:extLst>
              <a:ext uri="{FF2B5EF4-FFF2-40B4-BE49-F238E27FC236}">
                <a16:creationId xmlns:a16="http://schemas.microsoft.com/office/drawing/2014/main" id="{5C1F0F6B-D721-48EE-8397-9BBC2C7A364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58392267"/>
              </p:ext>
            </p:extLst>
          </p:nvPr>
        </p:nvGraphicFramePr>
        <p:xfrm>
          <a:off x="1081548" y="2525225"/>
          <a:ext cx="6980904" cy="242613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524000">
                  <a:extLst>
                    <a:ext uri="{9D8B030D-6E8A-4147-A177-3AD203B41FA5}">
                      <a16:colId xmlns:a16="http://schemas.microsoft.com/office/drawing/2014/main" val="650566353"/>
                    </a:ext>
                  </a:extLst>
                </a:gridCol>
                <a:gridCol w="2713704">
                  <a:extLst>
                    <a:ext uri="{9D8B030D-6E8A-4147-A177-3AD203B41FA5}">
                      <a16:colId xmlns:a16="http://schemas.microsoft.com/office/drawing/2014/main" val="61869086"/>
                    </a:ext>
                  </a:extLst>
                </a:gridCol>
                <a:gridCol w="2743200">
                  <a:extLst>
                    <a:ext uri="{9D8B030D-6E8A-4147-A177-3AD203B41FA5}">
                      <a16:colId xmlns:a16="http://schemas.microsoft.com/office/drawing/2014/main" val="2293351310"/>
                    </a:ext>
                  </a:extLst>
                </a:gridCol>
              </a:tblGrid>
              <a:tr h="26957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s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Reverse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70597106"/>
                  </a:ext>
                </a:extLst>
              </a:tr>
              <a:tr h="26957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C_Os03g0359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GTCAATGGCTAAACTGCTG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AGAGTGATCTGTTGTAGGC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84220993"/>
                  </a:ext>
                </a:extLst>
              </a:tr>
              <a:tr h="26957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C_Os03g0366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GGGGAATCAGTGCCAGAA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ATAGGAACGCAAGCATTGA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32533319"/>
                  </a:ext>
                </a:extLst>
              </a:tr>
              <a:tr h="26957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C_Os03g0368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GGCAGCGGACTTGGGTGC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AGATGTTCTCATTCCG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78808664"/>
                  </a:ext>
                </a:extLst>
              </a:tr>
              <a:tr h="26957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C_Os03g0370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GGCAGGGGGAGGAGGGGG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ACCGTTGTACACTGAAGG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94775029"/>
                  </a:ext>
                </a:extLst>
              </a:tr>
              <a:tr h="26957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C_Os03g0436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GGCGGGCGATCAGATGCA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ACGGCTGGCCGACCTCGT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0386239"/>
                  </a:ext>
                </a:extLst>
              </a:tr>
              <a:tr h="26957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C_Os03g0443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GCTGGCCGCGGTGATGGA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AATAGGTGCTGCTTAACA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24991926"/>
                  </a:ext>
                </a:extLst>
              </a:tr>
              <a:tr h="26957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C_Os03g0448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GGCCCTCCCCTGCGCCTT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AAGTGCAGAGCAACCTGT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39131603"/>
                  </a:ext>
                </a:extLst>
              </a:tr>
              <a:tr h="26957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C_Os03g0457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GGCGGTGACCGAGAGCTTG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AGTTCTGAATCTTTTTGGC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8921781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2311532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3353A942-22AF-477B-8861-A5D273002AF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67313852"/>
              </p:ext>
            </p:extLst>
          </p:nvPr>
        </p:nvGraphicFramePr>
        <p:xfrm>
          <a:off x="363415" y="2181472"/>
          <a:ext cx="8534400" cy="249505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81258">
                  <a:extLst>
                    <a:ext uri="{9D8B030D-6E8A-4147-A177-3AD203B41FA5}">
                      <a16:colId xmlns:a16="http://schemas.microsoft.com/office/drawing/2014/main" val="198382456"/>
                    </a:ext>
                  </a:extLst>
                </a:gridCol>
                <a:gridCol w="1734003">
                  <a:extLst>
                    <a:ext uri="{9D8B030D-6E8A-4147-A177-3AD203B41FA5}">
                      <a16:colId xmlns:a16="http://schemas.microsoft.com/office/drawing/2014/main" val="386970212"/>
                    </a:ext>
                  </a:extLst>
                </a:gridCol>
                <a:gridCol w="2971630">
                  <a:extLst>
                    <a:ext uri="{9D8B030D-6E8A-4147-A177-3AD203B41FA5}">
                      <a16:colId xmlns:a16="http://schemas.microsoft.com/office/drawing/2014/main" val="1610016190"/>
                    </a:ext>
                  </a:extLst>
                </a:gridCol>
                <a:gridCol w="2747509">
                  <a:extLst>
                    <a:ext uri="{9D8B030D-6E8A-4147-A177-3AD203B41FA5}">
                      <a16:colId xmlns:a16="http://schemas.microsoft.com/office/drawing/2014/main" val="1289385241"/>
                    </a:ext>
                  </a:extLst>
                </a:gridCol>
              </a:tblGrid>
              <a:tr h="291625">
                <a:tc>
                  <a:txBody>
                    <a:bodyPr/>
                    <a:lstStyle/>
                    <a:p>
                      <a:pPr marL="0" algn="l" defTabSz="914400" rtl="0" eaLnBrk="1" fontAlgn="ctr" latinLnBrk="0" hangingPunct="1"/>
                      <a:endParaRPr lang="zh-CN" altLang="en-US" sz="1400" u="none" strike="noStrike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984" marR="6984" marT="698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/>
                      <a:r>
                        <a:rPr lang="en-US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enes</a:t>
                      </a:r>
                    </a:p>
                  </a:txBody>
                  <a:tcPr marL="6984" marR="6984" marT="698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/>
                      <a:r>
                        <a:rPr lang="en-US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orward</a:t>
                      </a:r>
                    </a:p>
                  </a:txBody>
                  <a:tcPr marL="6984" marR="6984" marT="698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/>
                      <a:r>
                        <a:rPr lang="en-US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Reverse</a:t>
                      </a:r>
                    </a:p>
                  </a:txBody>
                  <a:tcPr marL="6984" marR="6984" marT="698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53479198"/>
                  </a:ext>
                </a:extLst>
              </a:tr>
              <a:tr h="400235">
                <a:tc>
                  <a:txBody>
                    <a:bodyPr/>
                    <a:lstStyle/>
                    <a:p>
                      <a:pPr marL="0" algn="l" defTabSz="914400" rtl="0" eaLnBrk="1" fontAlgn="ctr" latinLnBrk="0" hangingPunct="1"/>
                      <a:r>
                        <a:rPr lang="en-US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romoter</a:t>
                      </a:r>
                    </a:p>
                  </a:txBody>
                  <a:tcPr marL="6984" marR="6984" marT="698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/>
                      <a:r>
                        <a:rPr lang="en-US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OC_Os03g04360</a:t>
                      </a:r>
                    </a:p>
                  </a:txBody>
                  <a:tcPr marL="6984" marR="6984" marT="698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/>
                      <a:r>
                        <a:rPr lang="en-US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GAACATGACAACACAGGCT</a:t>
                      </a:r>
                    </a:p>
                  </a:txBody>
                  <a:tcPr marL="6984" marR="6984" marT="698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/>
                      <a:r>
                        <a:rPr lang="en-US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TGGCGGTGACGCTGCTGCT</a:t>
                      </a:r>
                    </a:p>
                  </a:txBody>
                  <a:tcPr marL="6984" marR="6984" marT="698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05162234"/>
                  </a:ext>
                </a:extLst>
              </a:tr>
              <a:tr h="400235">
                <a:tc>
                  <a:txBody>
                    <a:bodyPr/>
                    <a:lstStyle/>
                    <a:p>
                      <a:pPr marL="0" algn="l" defTabSz="914400" rtl="0" eaLnBrk="1" fontAlgn="ctr" latinLnBrk="0" hangingPunct="1"/>
                      <a:endParaRPr lang="zh-CN" altLang="en-US" sz="1400" u="none" strike="noStrike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984" marR="6984" marT="698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/>
                      <a:r>
                        <a:rPr lang="en-US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OC_Os03g04430</a:t>
                      </a:r>
                    </a:p>
                  </a:txBody>
                  <a:tcPr marL="6984" marR="6984" marT="698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/>
                      <a:r>
                        <a:rPr lang="en-US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CGGTTGCGTAAGAGAATCA</a:t>
                      </a:r>
                    </a:p>
                  </a:txBody>
                  <a:tcPr marL="6984" marR="6984" marT="698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/>
                      <a:r>
                        <a:rPr lang="en-US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CTTCATCTCACACTCTCCT</a:t>
                      </a:r>
                    </a:p>
                  </a:txBody>
                  <a:tcPr marL="6984" marR="6984" marT="698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86573478"/>
                  </a:ext>
                </a:extLst>
              </a:tr>
              <a:tr h="400235">
                <a:tc>
                  <a:txBody>
                    <a:bodyPr/>
                    <a:lstStyle/>
                    <a:p>
                      <a:pPr marL="0" algn="l" defTabSz="914400" rtl="0" eaLnBrk="1" fontAlgn="ctr" latinLnBrk="0" hangingPunct="1"/>
                      <a:endParaRPr lang="zh-CN" altLang="en-US" sz="1400" u="none" strike="noStrike" kern="120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984" marR="6984" marT="698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/>
                      <a:r>
                        <a:rPr lang="en-US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OC_Os03g04480</a:t>
                      </a:r>
                    </a:p>
                  </a:txBody>
                  <a:tcPr marL="6984" marR="6984" marT="698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/>
                      <a:r>
                        <a:rPr lang="en-US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TGGTCCCATGCCACCTTTG</a:t>
                      </a:r>
                    </a:p>
                  </a:txBody>
                  <a:tcPr marL="6984" marR="6984" marT="698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/>
                      <a:r>
                        <a:rPr lang="en-US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ACGAGAAGGAGGTGGCGTT</a:t>
                      </a:r>
                    </a:p>
                  </a:txBody>
                  <a:tcPr marL="6984" marR="6984" marT="698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87199832"/>
                  </a:ext>
                </a:extLst>
              </a:tr>
              <a:tr h="360905">
                <a:tc>
                  <a:txBody>
                    <a:bodyPr/>
                    <a:lstStyle/>
                    <a:p>
                      <a:pPr marL="0" algn="l" defTabSz="914400" rtl="0" eaLnBrk="1" fontAlgn="ctr" latinLnBrk="0" hangingPunct="1"/>
                      <a:r>
                        <a:rPr lang="en-US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ull-length</a:t>
                      </a:r>
                    </a:p>
                  </a:txBody>
                  <a:tcPr marL="6984" marR="6984" marT="698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/>
                      <a:r>
                        <a:rPr lang="en-US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OC_Os03g04360</a:t>
                      </a:r>
                    </a:p>
                  </a:txBody>
                  <a:tcPr marL="6984" marR="6984" marT="698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/>
                      <a:r>
                        <a:rPr lang="en-US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GGAAGCAGAGTTGTTACGA</a:t>
                      </a:r>
                    </a:p>
                  </a:txBody>
                  <a:tcPr marL="6984" marR="6984" marT="698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/>
                      <a:r>
                        <a:rPr lang="en-US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TTGATCTGACCTCGCTGTT</a:t>
                      </a:r>
                    </a:p>
                  </a:txBody>
                  <a:tcPr marL="6984" marR="6984" marT="698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90999318"/>
                  </a:ext>
                </a:extLst>
              </a:tr>
              <a:tr h="320910">
                <a:tc>
                  <a:txBody>
                    <a:bodyPr/>
                    <a:lstStyle/>
                    <a:p>
                      <a:pPr marL="0" algn="l" defTabSz="914400" rtl="0" eaLnBrk="1" fontAlgn="ctr" latinLnBrk="0" hangingPunct="1"/>
                      <a:endParaRPr lang="zh-CN" altLang="en-US" sz="1400" u="none" strike="noStrike" kern="120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984" marR="6984" marT="698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/>
                      <a:r>
                        <a:rPr lang="en-US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OC_Os03g04430</a:t>
                      </a:r>
                    </a:p>
                  </a:txBody>
                  <a:tcPr marL="6984" marR="6984" marT="698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/>
                      <a:r>
                        <a:rPr lang="en-US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TGAACGCACAAACGGTATT</a:t>
                      </a:r>
                    </a:p>
                  </a:txBody>
                  <a:tcPr marL="6984" marR="6984" marT="698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/>
                      <a:r>
                        <a:rPr lang="en-US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CTTATTACTGGTGTGCCGA</a:t>
                      </a:r>
                    </a:p>
                  </a:txBody>
                  <a:tcPr marL="6984" marR="6984" marT="698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1505609"/>
                  </a:ext>
                </a:extLst>
              </a:tr>
              <a:tr h="320910">
                <a:tc>
                  <a:txBody>
                    <a:bodyPr/>
                    <a:lstStyle/>
                    <a:p>
                      <a:pPr marL="0" algn="l" defTabSz="914400" rtl="0" eaLnBrk="1" fontAlgn="ctr" latinLnBrk="0" hangingPunct="1"/>
                      <a:endParaRPr lang="zh-CN" altLang="en-US" sz="1400" u="none" strike="noStrike" kern="120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984" marR="6984" marT="698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/>
                      <a:r>
                        <a:rPr lang="en-US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OC_Os03g04480</a:t>
                      </a:r>
                    </a:p>
                  </a:txBody>
                  <a:tcPr marL="6984" marR="6984" marT="698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/>
                      <a:r>
                        <a:rPr lang="en-US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GCAACTGGCTCTGGAGATC</a:t>
                      </a:r>
                    </a:p>
                  </a:txBody>
                  <a:tcPr marL="6984" marR="6984" marT="698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/>
                      <a:r>
                        <a:rPr lang="en-US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TCCTGTTCCGCTACTCCAT</a:t>
                      </a:r>
                    </a:p>
                  </a:txBody>
                  <a:tcPr marL="6984" marR="6984" marT="6984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84379397"/>
                  </a:ext>
                </a:extLst>
              </a:tr>
            </a:tbl>
          </a:graphicData>
        </a:graphic>
      </p:graphicFrame>
      <p:sp>
        <p:nvSpPr>
          <p:cNvPr id="5" name="文本框 83971">
            <a:extLst>
              <a:ext uri="{FF2B5EF4-FFF2-40B4-BE49-F238E27FC236}">
                <a16:creationId xmlns:a16="http://schemas.microsoft.com/office/drawing/2014/main" id="{65107F63-3720-43BD-AFC5-46D94084FCE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0985" y="822266"/>
            <a:ext cx="8018583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4. Primers used to amplify the </a:t>
            </a:r>
            <a:r>
              <a:rPr lang="en-US" altLang="zh-CN" b="1">
                <a:latin typeface="Times New Roman" panose="02020603050405020304" pitchFamily="18" charset="0"/>
                <a:cs typeface="Times New Roman" panose="02020603050405020304" pitchFamily="18" charset="0"/>
              </a:rPr>
              <a:t>full-length promoter 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pt-BR" altLang="zh-CN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C_Os03g04360</a:t>
            </a:r>
            <a:r>
              <a:rPr lang="pt-BR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pt-BR" altLang="zh-CN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C_Os03g04430 </a:t>
            </a:r>
            <a:r>
              <a:rPr lang="pt-BR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pt-BR" altLang="zh-CN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C_Os03g04480</a:t>
            </a:r>
            <a:endParaRPr lang="en-US" altLang="zh-CN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8055350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CE2FC43D-5D36-4311-B5B4-097EF1CD2A82}"/>
              </a:ext>
            </a:extLst>
          </p:cNvPr>
          <p:cNvGrpSpPr/>
          <p:nvPr/>
        </p:nvGrpSpPr>
        <p:grpSpPr>
          <a:xfrm>
            <a:off x="188426" y="1283604"/>
            <a:ext cx="8617780" cy="5181891"/>
            <a:chOff x="-760" y="831658"/>
            <a:chExt cx="8617780" cy="5181891"/>
          </a:xfrm>
        </p:grpSpPr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11EB8594-9F6E-4760-9B43-7DE173DF14D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0" y="1106746"/>
              <a:ext cx="2756752" cy="1260000"/>
            </a:xfrm>
            <a:prstGeom prst="rect">
              <a:avLst/>
            </a:prstGeom>
          </p:spPr>
        </p:pic>
        <p:sp>
          <p:nvSpPr>
            <p:cNvPr id="5" name="矩形 4">
              <a:extLst>
                <a:ext uri="{FF2B5EF4-FFF2-40B4-BE49-F238E27FC236}">
                  <a16:creationId xmlns:a16="http://schemas.microsoft.com/office/drawing/2014/main" id="{8ED13883-7633-4ED3-BF3E-6A323BD54C5E}"/>
                </a:ext>
              </a:extLst>
            </p:cNvPr>
            <p:cNvSpPr/>
            <p:nvPr/>
          </p:nvSpPr>
          <p:spPr>
            <a:xfrm>
              <a:off x="615157" y="831658"/>
              <a:ext cx="1792478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C_Os03g03590</a:t>
              </a:r>
              <a:endParaRPr lang="zh-CN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FA12DF67-91AA-44CD-BBDE-5140E47DE17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875924" y="1106746"/>
              <a:ext cx="2800451" cy="1260000"/>
            </a:xfrm>
            <a:prstGeom prst="rect">
              <a:avLst/>
            </a:prstGeom>
          </p:spPr>
        </p:pic>
        <p:sp>
          <p:nvSpPr>
            <p:cNvPr id="7" name="矩形 6">
              <a:extLst>
                <a:ext uri="{FF2B5EF4-FFF2-40B4-BE49-F238E27FC236}">
                  <a16:creationId xmlns:a16="http://schemas.microsoft.com/office/drawing/2014/main" id="{F14CF3E1-E8E1-4BED-9AD9-048A86415830}"/>
                </a:ext>
              </a:extLst>
            </p:cNvPr>
            <p:cNvSpPr/>
            <p:nvPr/>
          </p:nvSpPr>
          <p:spPr>
            <a:xfrm>
              <a:off x="3624606" y="835285"/>
              <a:ext cx="1792478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C_Os03g03680</a:t>
              </a:r>
            </a:p>
          </p:txBody>
        </p:sp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852C4877-58B1-4383-9AC0-C5D92E21FD6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816569" y="1106746"/>
              <a:ext cx="2800451" cy="1260000"/>
            </a:xfrm>
            <a:prstGeom prst="rect">
              <a:avLst/>
            </a:prstGeom>
          </p:spPr>
        </p:pic>
        <p:sp>
          <p:nvSpPr>
            <p:cNvPr id="9" name="矩形 8">
              <a:extLst>
                <a:ext uri="{FF2B5EF4-FFF2-40B4-BE49-F238E27FC236}">
                  <a16:creationId xmlns:a16="http://schemas.microsoft.com/office/drawing/2014/main" id="{0C8AE51D-2F37-4FE3-B6E8-4A7BE6EA0912}"/>
                </a:ext>
              </a:extLst>
            </p:cNvPr>
            <p:cNvSpPr/>
            <p:nvPr/>
          </p:nvSpPr>
          <p:spPr>
            <a:xfrm>
              <a:off x="6425057" y="831658"/>
              <a:ext cx="1792478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C_Os03g03700</a:t>
              </a:r>
            </a:p>
          </p:txBody>
        </p:sp>
        <p:pic>
          <p:nvPicPr>
            <p:cNvPr id="10" name="图片 9">
              <a:extLst>
                <a:ext uri="{FF2B5EF4-FFF2-40B4-BE49-F238E27FC236}">
                  <a16:creationId xmlns:a16="http://schemas.microsoft.com/office/drawing/2014/main" id="{5A85694C-4AE8-41B7-BA2A-7E3730DB05F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0" y="2885639"/>
              <a:ext cx="2770384" cy="1260000"/>
            </a:xfrm>
            <a:prstGeom prst="rect">
              <a:avLst/>
            </a:prstGeom>
          </p:spPr>
        </p:pic>
        <p:sp>
          <p:nvSpPr>
            <p:cNvPr id="11" name="矩形 10">
              <a:extLst>
                <a:ext uri="{FF2B5EF4-FFF2-40B4-BE49-F238E27FC236}">
                  <a16:creationId xmlns:a16="http://schemas.microsoft.com/office/drawing/2014/main" id="{3332C800-089B-41D1-BCDB-123350507C8A}"/>
                </a:ext>
              </a:extLst>
            </p:cNvPr>
            <p:cNvSpPr/>
            <p:nvPr/>
          </p:nvSpPr>
          <p:spPr>
            <a:xfrm>
              <a:off x="583626" y="2561159"/>
              <a:ext cx="1792478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C_Os03g03949</a:t>
              </a:r>
            </a:p>
          </p:txBody>
        </p:sp>
        <p:pic>
          <p:nvPicPr>
            <p:cNvPr id="12" name="图片 11">
              <a:extLst>
                <a:ext uri="{FF2B5EF4-FFF2-40B4-BE49-F238E27FC236}">
                  <a16:creationId xmlns:a16="http://schemas.microsoft.com/office/drawing/2014/main" id="{9A926376-F96F-44A0-9C69-F99202BCB368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870970" y="2879713"/>
              <a:ext cx="2779292" cy="1260000"/>
            </a:xfrm>
            <a:prstGeom prst="rect">
              <a:avLst/>
            </a:prstGeom>
          </p:spPr>
        </p:pic>
        <p:sp>
          <p:nvSpPr>
            <p:cNvPr id="13" name="矩形 12">
              <a:extLst>
                <a:ext uri="{FF2B5EF4-FFF2-40B4-BE49-F238E27FC236}">
                  <a16:creationId xmlns:a16="http://schemas.microsoft.com/office/drawing/2014/main" id="{59281266-DDE6-4431-81A9-7855CB996BB8}"/>
                </a:ext>
              </a:extLst>
            </p:cNvPr>
            <p:cNvSpPr/>
            <p:nvPr/>
          </p:nvSpPr>
          <p:spPr>
            <a:xfrm>
              <a:off x="3624606" y="2546374"/>
              <a:ext cx="1792478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C_Os03g04360</a:t>
              </a:r>
            </a:p>
          </p:txBody>
        </p:sp>
        <p:pic>
          <p:nvPicPr>
            <p:cNvPr id="14" name="图片 13">
              <a:extLst>
                <a:ext uri="{FF2B5EF4-FFF2-40B4-BE49-F238E27FC236}">
                  <a16:creationId xmlns:a16="http://schemas.microsoft.com/office/drawing/2014/main" id="{D054093F-205D-4EF7-B7DE-3FBE682C9322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5785955" y="2879713"/>
              <a:ext cx="2774421" cy="1260000"/>
            </a:xfrm>
            <a:prstGeom prst="rect">
              <a:avLst/>
            </a:prstGeom>
          </p:spPr>
        </p:pic>
        <p:sp>
          <p:nvSpPr>
            <p:cNvPr id="15" name="矩形 14">
              <a:extLst>
                <a:ext uri="{FF2B5EF4-FFF2-40B4-BE49-F238E27FC236}">
                  <a16:creationId xmlns:a16="http://schemas.microsoft.com/office/drawing/2014/main" id="{26A466F1-5A58-48B7-B9EF-2EFD850A6676}"/>
                </a:ext>
              </a:extLst>
            </p:cNvPr>
            <p:cNvSpPr/>
            <p:nvPr/>
          </p:nvSpPr>
          <p:spPr>
            <a:xfrm>
              <a:off x="6504484" y="2561159"/>
              <a:ext cx="1792478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C_Os03g04480</a:t>
              </a:r>
            </a:p>
          </p:txBody>
        </p:sp>
        <p:pic>
          <p:nvPicPr>
            <p:cNvPr id="16" name="图片 15">
              <a:extLst>
                <a:ext uri="{FF2B5EF4-FFF2-40B4-BE49-F238E27FC236}">
                  <a16:creationId xmlns:a16="http://schemas.microsoft.com/office/drawing/2014/main" id="{E14E85F7-2AB2-415B-90BB-49488DE4F62A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-760" y="4753549"/>
              <a:ext cx="2837032" cy="1260000"/>
            </a:xfrm>
            <a:prstGeom prst="rect">
              <a:avLst/>
            </a:prstGeom>
          </p:spPr>
        </p:pic>
        <p:sp>
          <p:nvSpPr>
            <p:cNvPr id="17" name="矩形 16">
              <a:extLst>
                <a:ext uri="{FF2B5EF4-FFF2-40B4-BE49-F238E27FC236}">
                  <a16:creationId xmlns:a16="http://schemas.microsoft.com/office/drawing/2014/main" id="{85BFF223-E511-4037-A824-61FAC5AAD6CF}"/>
                </a:ext>
              </a:extLst>
            </p:cNvPr>
            <p:cNvSpPr/>
            <p:nvPr/>
          </p:nvSpPr>
          <p:spPr>
            <a:xfrm>
              <a:off x="615157" y="4450871"/>
              <a:ext cx="1792478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C_Os03g04570</a:t>
              </a:r>
            </a:p>
          </p:txBody>
        </p:sp>
        <p:pic>
          <p:nvPicPr>
            <p:cNvPr id="18" name="图片 17">
              <a:extLst>
                <a:ext uri="{FF2B5EF4-FFF2-40B4-BE49-F238E27FC236}">
                  <a16:creationId xmlns:a16="http://schemas.microsoft.com/office/drawing/2014/main" id="{D4240084-B84B-4FD7-8222-9FE70F6F2703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2870970" y="4747623"/>
              <a:ext cx="2812644" cy="1260000"/>
            </a:xfrm>
            <a:prstGeom prst="rect">
              <a:avLst/>
            </a:prstGeom>
          </p:spPr>
        </p:pic>
        <p:sp>
          <p:nvSpPr>
            <p:cNvPr id="19" name="矩形 18">
              <a:extLst>
                <a:ext uri="{FF2B5EF4-FFF2-40B4-BE49-F238E27FC236}">
                  <a16:creationId xmlns:a16="http://schemas.microsoft.com/office/drawing/2014/main" id="{BCEDA516-B279-4B77-ABA4-7566ECBAFE50}"/>
                </a:ext>
              </a:extLst>
            </p:cNvPr>
            <p:cNvSpPr/>
            <p:nvPr/>
          </p:nvSpPr>
          <p:spPr>
            <a:xfrm>
              <a:off x="3624606" y="4450871"/>
              <a:ext cx="1792478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C_Os03g05290</a:t>
              </a:r>
            </a:p>
          </p:txBody>
        </p:sp>
      </p:grpSp>
      <p:sp>
        <p:nvSpPr>
          <p:cNvPr id="20" name="Text Box 3">
            <a:extLst>
              <a:ext uri="{FF2B5EF4-FFF2-40B4-BE49-F238E27FC236}">
                <a16:creationId xmlns:a16="http://schemas.microsoft.com/office/drawing/2014/main" id="{01D01C00-EABA-48AC-AB85-AE8F84491A7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39632" y="425651"/>
            <a:ext cx="732939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pPr algn="ctr"/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sym typeface="黑体" panose="02010609060101010101" pitchFamily="49" charset="-122"/>
              </a:rPr>
              <a:t>Figure S1. Topological model of proteins encoded by candidate genes</a:t>
            </a:r>
            <a:endParaRPr lang="zh-CN" altLang="en-US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5857750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矩形 12">
            <a:extLst>
              <a:ext uri="{FF2B5EF4-FFF2-40B4-BE49-F238E27FC236}">
                <a16:creationId xmlns:a16="http://schemas.microsoft.com/office/drawing/2014/main" id="{EB22AA9F-0882-4AEF-A468-64627A894B58}"/>
              </a:ext>
            </a:extLst>
          </p:cNvPr>
          <p:cNvSpPr/>
          <p:nvPr/>
        </p:nvSpPr>
        <p:spPr>
          <a:xfrm>
            <a:off x="1143381" y="1139948"/>
            <a:ext cx="6858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Expression of the candidate genes in yeast mutant CM66 in liquid medium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22655828-FE80-410C-9266-EA9F14946396}"/>
              </a:ext>
            </a:extLst>
          </p:cNvPr>
          <p:cNvGrpSpPr/>
          <p:nvPr/>
        </p:nvGrpSpPr>
        <p:grpSpPr>
          <a:xfrm>
            <a:off x="41116" y="2495572"/>
            <a:ext cx="9047004" cy="2459886"/>
            <a:chOff x="41116" y="2495572"/>
            <a:chExt cx="9047004" cy="2459886"/>
          </a:xfrm>
        </p:grpSpPr>
        <p:pic>
          <p:nvPicPr>
            <p:cNvPr id="16" name="图片 15">
              <a:extLst>
                <a:ext uri="{FF2B5EF4-FFF2-40B4-BE49-F238E27FC236}">
                  <a16:creationId xmlns:a16="http://schemas.microsoft.com/office/drawing/2014/main" id="{84DCA182-B9F7-494F-8667-04E2538B346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7600" y="2556274"/>
              <a:ext cx="3024000" cy="2391191"/>
            </a:xfrm>
            <a:prstGeom prst="rect">
              <a:avLst/>
            </a:prstGeom>
          </p:spPr>
        </p:pic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955C88D1-CE82-4925-8F05-054A2527A4C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056438" y="2556760"/>
              <a:ext cx="3024000" cy="2397637"/>
            </a:xfrm>
            <a:prstGeom prst="rect">
              <a:avLst/>
            </a:prstGeom>
          </p:spPr>
        </p:pic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4B40CCAF-2164-47DE-B89B-7AD946C2799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064120" y="2556760"/>
              <a:ext cx="3024000" cy="2398698"/>
            </a:xfrm>
            <a:prstGeom prst="rect">
              <a:avLst/>
            </a:prstGeom>
          </p:spPr>
        </p:pic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A39BE4B8-767B-42D0-B29A-6499F62D69D8}"/>
                </a:ext>
              </a:extLst>
            </p:cNvPr>
            <p:cNvSpPr txBox="1"/>
            <p:nvPr/>
          </p:nvSpPr>
          <p:spPr>
            <a:xfrm>
              <a:off x="41116" y="2500825"/>
              <a:ext cx="34978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                         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DD0F6372-78F8-4E12-90CE-E59861BC451F}"/>
                </a:ext>
              </a:extLst>
            </p:cNvPr>
            <p:cNvSpPr txBox="1"/>
            <p:nvPr/>
          </p:nvSpPr>
          <p:spPr>
            <a:xfrm>
              <a:off x="3041806" y="2495572"/>
              <a:ext cx="34978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                         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21073105-016C-4D30-A43C-CA293668DBE2}"/>
                </a:ext>
              </a:extLst>
            </p:cNvPr>
            <p:cNvSpPr txBox="1"/>
            <p:nvPr/>
          </p:nvSpPr>
          <p:spPr>
            <a:xfrm>
              <a:off x="6042500" y="2500829"/>
              <a:ext cx="34978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                         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12BE2C59-2CE7-41B6-888E-312A7166D7FF}"/>
                </a:ext>
              </a:extLst>
            </p:cNvPr>
            <p:cNvSpPr txBox="1"/>
            <p:nvPr/>
          </p:nvSpPr>
          <p:spPr>
            <a:xfrm>
              <a:off x="2744593" y="3671550"/>
              <a:ext cx="27163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en-US" altLang="zh-CN" sz="14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52614308-552F-4F7A-9067-246A173A668B}"/>
                </a:ext>
              </a:extLst>
            </p:cNvPr>
            <p:cNvSpPr txBox="1"/>
            <p:nvPr/>
          </p:nvSpPr>
          <p:spPr>
            <a:xfrm>
              <a:off x="2424034" y="4013135"/>
              <a:ext cx="27163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en-US" altLang="zh-CN" sz="14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DC9AD69E-E5C3-4877-9A9E-498991EED1CF}"/>
                </a:ext>
              </a:extLst>
            </p:cNvPr>
            <p:cNvSpPr txBox="1"/>
            <p:nvPr/>
          </p:nvSpPr>
          <p:spPr>
            <a:xfrm>
              <a:off x="2108715" y="4275891"/>
              <a:ext cx="27163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en-US" altLang="zh-CN" sz="14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54EB1381-FFDE-4D60-A967-90F982BC441E}"/>
                </a:ext>
              </a:extLst>
            </p:cNvPr>
            <p:cNvSpPr txBox="1"/>
            <p:nvPr/>
          </p:nvSpPr>
          <p:spPr>
            <a:xfrm>
              <a:off x="4783590" y="4218087"/>
              <a:ext cx="27163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en-US" altLang="zh-CN" sz="14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90176599-AC89-43EE-9E95-05B4F815EC6A}"/>
                </a:ext>
              </a:extLst>
            </p:cNvPr>
            <p:cNvSpPr txBox="1"/>
            <p:nvPr/>
          </p:nvSpPr>
          <p:spPr>
            <a:xfrm>
              <a:off x="5083130" y="3918550"/>
              <a:ext cx="27163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en-US" altLang="zh-CN" sz="14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7B3B829D-5869-48D1-92F1-00657FCF8FF6}"/>
                </a:ext>
              </a:extLst>
            </p:cNvPr>
            <p:cNvSpPr txBox="1"/>
            <p:nvPr/>
          </p:nvSpPr>
          <p:spPr>
            <a:xfrm>
              <a:off x="5424711" y="3146041"/>
              <a:ext cx="27163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en-US" altLang="zh-CN" sz="14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317D2EF0-392A-4497-9A9B-435A14307393}"/>
                </a:ext>
              </a:extLst>
            </p:cNvPr>
            <p:cNvSpPr txBox="1"/>
            <p:nvPr/>
          </p:nvSpPr>
          <p:spPr>
            <a:xfrm>
              <a:off x="5734762" y="2772922"/>
              <a:ext cx="27163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en-US" altLang="zh-CN" sz="14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32189491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 Box 3">
            <a:extLst>
              <a:ext uri="{FF2B5EF4-FFF2-40B4-BE49-F238E27FC236}">
                <a16:creationId xmlns:a16="http://schemas.microsoft.com/office/drawing/2014/main" id="{8B6CDFB9-2E31-4184-B083-0DCA23624E9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53383" y="609371"/>
            <a:ext cx="7385538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pPr algn="ctr"/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sym typeface="黑体" panose="02010609060101010101" pitchFamily="49" charset="-122"/>
              </a:rPr>
              <a:t>Figure S3. Sequence and expression of </a:t>
            </a:r>
            <a:r>
              <a:rPr lang="en-US" altLang="zh-CN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C_Os03g04430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</a:t>
            </a:r>
            <a:r>
              <a:rPr lang="en-US" altLang="zh-CN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b="1" i="1" dirty="0">
                <a:latin typeface="Times New Roman" panose="02020603050405020304" pitchFamily="18" charset="0"/>
                <a:ea typeface="黑体" panose="02010609060101010101" pitchFamily="49" charset="-122"/>
                <a:sym typeface="黑体" panose="02010609060101010101" pitchFamily="49" charset="-122"/>
              </a:rPr>
              <a:t>LOC_Os03g04480 </a:t>
            </a:r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sym typeface="黑体" panose="02010609060101010101" pitchFamily="49" charset="-122"/>
              </a:rPr>
              <a:t>in four parents lines </a:t>
            </a:r>
            <a:endParaRPr lang="zh-CN" altLang="en-US" b="1" dirty="0"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grpSp>
        <p:nvGrpSpPr>
          <p:cNvPr id="4" name="组合 3">
            <a:extLst>
              <a:ext uri="{FF2B5EF4-FFF2-40B4-BE49-F238E27FC236}">
                <a16:creationId xmlns:a16="http://schemas.microsoft.com/office/drawing/2014/main" id="{2A808521-E916-4680-8D1B-CFC4DBFEF351}"/>
              </a:ext>
            </a:extLst>
          </p:cNvPr>
          <p:cNvGrpSpPr/>
          <p:nvPr/>
        </p:nvGrpSpPr>
        <p:grpSpPr>
          <a:xfrm>
            <a:off x="1564384" y="1585956"/>
            <a:ext cx="6163535" cy="4662673"/>
            <a:chOff x="1359185" y="1491596"/>
            <a:chExt cx="6163535" cy="4662673"/>
          </a:xfrm>
        </p:grpSpPr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5C56BCAE-F4E6-45AB-A7F7-861EBDDB975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495977" y="3634269"/>
              <a:ext cx="2950575" cy="2520000"/>
            </a:xfrm>
            <a:prstGeom prst="rect">
              <a:avLst/>
            </a:prstGeom>
          </p:spPr>
        </p:pic>
        <p:pic>
          <p:nvPicPr>
            <p:cNvPr id="11" name="图片 10">
              <a:extLst>
                <a:ext uri="{FF2B5EF4-FFF2-40B4-BE49-F238E27FC236}">
                  <a16:creationId xmlns:a16="http://schemas.microsoft.com/office/drawing/2014/main" id="{4CAB39CC-5525-4080-8B21-F5BA19EA5DA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572000" y="3634269"/>
              <a:ext cx="2950720" cy="2517866"/>
            </a:xfrm>
            <a:prstGeom prst="rect">
              <a:avLst/>
            </a:prstGeom>
          </p:spPr>
        </p:pic>
        <p:grpSp>
          <p:nvGrpSpPr>
            <p:cNvPr id="34" name="组合 33">
              <a:extLst>
                <a:ext uri="{FF2B5EF4-FFF2-40B4-BE49-F238E27FC236}">
                  <a16:creationId xmlns:a16="http://schemas.microsoft.com/office/drawing/2014/main" id="{D4D61C14-8C82-4FD3-9249-5AAC148F69E3}"/>
                </a:ext>
              </a:extLst>
            </p:cNvPr>
            <p:cNvGrpSpPr/>
            <p:nvPr/>
          </p:nvGrpSpPr>
          <p:grpSpPr>
            <a:xfrm>
              <a:off x="1394380" y="2287773"/>
              <a:ext cx="5986199" cy="1005776"/>
              <a:chOff x="3141604" y="3088380"/>
              <a:chExt cx="5925415" cy="1005776"/>
            </a:xfrm>
          </p:grpSpPr>
          <p:grpSp>
            <p:nvGrpSpPr>
              <p:cNvPr id="35" name="组合 34">
                <a:extLst>
                  <a:ext uri="{FF2B5EF4-FFF2-40B4-BE49-F238E27FC236}">
                    <a16:creationId xmlns:a16="http://schemas.microsoft.com/office/drawing/2014/main" id="{BB540AEA-E49A-424C-B322-819582E6EA5E}"/>
                  </a:ext>
                </a:extLst>
              </p:cNvPr>
              <p:cNvGrpSpPr/>
              <p:nvPr/>
            </p:nvGrpSpPr>
            <p:grpSpPr>
              <a:xfrm>
                <a:off x="3141604" y="3088380"/>
                <a:ext cx="5925415" cy="1005776"/>
                <a:chOff x="3076972" y="1433908"/>
                <a:chExt cx="5419031" cy="1005776"/>
              </a:xfrm>
            </p:grpSpPr>
            <p:grpSp>
              <p:nvGrpSpPr>
                <p:cNvPr id="37" name="组合 36">
                  <a:extLst>
                    <a:ext uri="{FF2B5EF4-FFF2-40B4-BE49-F238E27FC236}">
                      <a16:creationId xmlns:a16="http://schemas.microsoft.com/office/drawing/2014/main" id="{CD6EEBCB-CE1C-4855-88E7-226A3D97BC34}"/>
                    </a:ext>
                  </a:extLst>
                </p:cNvPr>
                <p:cNvGrpSpPr/>
                <p:nvPr/>
              </p:nvGrpSpPr>
              <p:grpSpPr>
                <a:xfrm>
                  <a:off x="3493129" y="1433908"/>
                  <a:ext cx="5002874" cy="572691"/>
                  <a:chOff x="1296547" y="3507760"/>
                  <a:chExt cx="5002874" cy="572691"/>
                </a:xfrm>
              </p:grpSpPr>
              <p:grpSp>
                <p:nvGrpSpPr>
                  <p:cNvPr id="41" name="组合 40">
                    <a:extLst>
                      <a:ext uri="{FF2B5EF4-FFF2-40B4-BE49-F238E27FC236}">
                        <a16:creationId xmlns:a16="http://schemas.microsoft.com/office/drawing/2014/main" id="{CA1E2A8A-AAF4-4DC2-907C-8EA47481CBD9}"/>
                      </a:ext>
                    </a:extLst>
                  </p:cNvPr>
                  <p:cNvGrpSpPr/>
                  <p:nvPr/>
                </p:nvGrpSpPr>
                <p:grpSpPr>
                  <a:xfrm>
                    <a:off x="1296547" y="3960402"/>
                    <a:ext cx="4909814" cy="120049"/>
                    <a:chOff x="1302954" y="3225619"/>
                    <a:chExt cx="4909814" cy="81864"/>
                  </a:xfrm>
                </p:grpSpPr>
                <p:sp>
                  <p:nvSpPr>
                    <p:cNvPr id="45" name="箭头: 五边形 44">
                      <a:extLst>
                        <a:ext uri="{FF2B5EF4-FFF2-40B4-BE49-F238E27FC236}">
                          <a16:creationId xmlns:a16="http://schemas.microsoft.com/office/drawing/2014/main" id="{DDEE6917-ED6A-4F29-8713-7C5FDA1CBDAD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978768" y="3227002"/>
                      <a:ext cx="234000" cy="79894"/>
                    </a:xfrm>
                    <a:prstGeom prst="homePlate">
                      <a:avLst/>
                    </a:prstGeom>
                    <a:noFill/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000" b="1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46" name="矩形 45">
                      <a:extLst>
                        <a:ext uri="{FF2B5EF4-FFF2-40B4-BE49-F238E27FC236}">
                          <a16:creationId xmlns:a16="http://schemas.microsoft.com/office/drawing/2014/main" id="{7251863D-97E2-451C-A340-5C698D676D99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716911" y="3227002"/>
                      <a:ext cx="273600" cy="79899"/>
                    </a:xfrm>
                    <a:prstGeom prst="rect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000" b="1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cxnSp>
                  <p:nvCxnSpPr>
                    <p:cNvPr id="47" name="直接连接符 46">
                      <a:extLst>
                        <a:ext uri="{FF2B5EF4-FFF2-40B4-BE49-F238E27FC236}">
                          <a16:creationId xmlns:a16="http://schemas.microsoft.com/office/drawing/2014/main" id="{8FE2F217-78BA-4A6E-B5FB-350302C98880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5593263" y="3266365"/>
                      <a:ext cx="1188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8" name="矩形 47">
                      <a:extLst>
                        <a:ext uri="{FF2B5EF4-FFF2-40B4-BE49-F238E27FC236}">
                          <a16:creationId xmlns:a16="http://schemas.microsoft.com/office/drawing/2014/main" id="{F0AD7FDD-6123-423D-AF69-C75ECCCA08DB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341263" y="3227002"/>
                      <a:ext cx="252000" cy="79899"/>
                    </a:xfrm>
                    <a:prstGeom prst="rect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000" b="1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cxnSp>
                  <p:nvCxnSpPr>
                    <p:cNvPr id="49" name="直接连接符 48">
                      <a:extLst>
                        <a:ext uri="{FF2B5EF4-FFF2-40B4-BE49-F238E27FC236}">
                          <a16:creationId xmlns:a16="http://schemas.microsoft.com/office/drawing/2014/main" id="{94EE6EE1-73BA-417B-A456-5F619B7672F2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5038051" y="3267535"/>
                      <a:ext cx="306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50" name="矩形 49">
                      <a:extLst>
                        <a:ext uri="{FF2B5EF4-FFF2-40B4-BE49-F238E27FC236}">
                          <a16:creationId xmlns:a16="http://schemas.microsoft.com/office/drawing/2014/main" id="{9E6D2ED1-52BD-4B5A-8CBB-CABAAD399FED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620451" y="3227588"/>
                      <a:ext cx="417600" cy="79895"/>
                    </a:xfrm>
                    <a:prstGeom prst="rect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000" b="1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cxnSp>
                  <p:nvCxnSpPr>
                    <p:cNvPr id="51" name="直接连接符 50">
                      <a:extLst>
                        <a:ext uri="{FF2B5EF4-FFF2-40B4-BE49-F238E27FC236}">
                          <a16:creationId xmlns:a16="http://schemas.microsoft.com/office/drawing/2014/main" id="{E1D635EB-44A1-4144-9A60-0AAFB6B5CF6D}"/>
                        </a:ext>
                      </a:extLst>
                    </p:cNvPr>
                    <p:cNvCxnSpPr>
                      <a:cxnSpLocks/>
                      <a:stCxn id="52" idx="3"/>
                      <a:endCxn id="50" idx="1"/>
                    </p:cNvCxnSpPr>
                    <p:nvPr/>
                  </p:nvCxnSpPr>
                  <p:spPr>
                    <a:xfrm>
                      <a:off x="4506541" y="3267535"/>
                      <a:ext cx="113910" cy="1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52" name="矩形 51">
                      <a:extLst>
                        <a:ext uri="{FF2B5EF4-FFF2-40B4-BE49-F238E27FC236}">
                          <a16:creationId xmlns:a16="http://schemas.microsoft.com/office/drawing/2014/main" id="{20240196-215F-4DC9-A8F5-74E617BA1746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193341" y="3227588"/>
                      <a:ext cx="313200" cy="79894"/>
                    </a:xfrm>
                    <a:prstGeom prst="rect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000" b="1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53" name="矩形 52">
                      <a:extLst>
                        <a:ext uri="{FF2B5EF4-FFF2-40B4-BE49-F238E27FC236}">
                          <a16:creationId xmlns:a16="http://schemas.microsoft.com/office/drawing/2014/main" id="{682863CE-558A-40A2-AC01-8F91AE131211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302954" y="3225619"/>
                      <a:ext cx="2673016" cy="79307"/>
                    </a:xfrm>
                    <a:prstGeom prst="rect">
                      <a:avLst/>
                    </a:prstGeom>
                    <a:solidFill>
                      <a:srgbClr val="FFC000"/>
                    </a:solidFill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  <p:sp>
                <p:nvSpPr>
                  <p:cNvPr id="42" name="文本框 41">
                    <a:extLst>
                      <a:ext uri="{FF2B5EF4-FFF2-40B4-BE49-F238E27FC236}">
                        <a16:creationId xmlns:a16="http://schemas.microsoft.com/office/drawing/2014/main" id="{9808C576-105D-450E-B481-B4C3C8F2DB6E}"/>
                      </a:ext>
                    </a:extLst>
                  </p:cNvPr>
                  <p:cNvSpPr txBox="1"/>
                  <p:nvPr/>
                </p:nvSpPr>
                <p:spPr>
                  <a:xfrm>
                    <a:off x="3980077" y="3766923"/>
                    <a:ext cx="532659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000" b="1" dirty="0">
                        <a:solidFill>
                          <a:schemeClr val="accent6">
                            <a:lumMod val="7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TG</a:t>
                    </a:r>
                    <a:endParaRPr lang="zh-CN" altLang="en-US" sz="1000" b="1" dirty="0">
                      <a:solidFill>
                        <a:schemeClr val="accent6">
                          <a:lumMod val="75000"/>
                        </a:scheme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3" name="文本框 42">
                    <a:extLst>
                      <a:ext uri="{FF2B5EF4-FFF2-40B4-BE49-F238E27FC236}">
                        <a16:creationId xmlns:a16="http://schemas.microsoft.com/office/drawing/2014/main" id="{3E74D894-3615-4DC4-8B46-7F010462CBF9}"/>
                      </a:ext>
                    </a:extLst>
                  </p:cNvPr>
                  <p:cNvSpPr txBox="1"/>
                  <p:nvPr/>
                </p:nvSpPr>
                <p:spPr>
                  <a:xfrm>
                    <a:off x="5766761" y="3761936"/>
                    <a:ext cx="532660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000" b="1" dirty="0">
                        <a:solidFill>
                          <a:schemeClr val="accent6">
                            <a:lumMod val="7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GA</a:t>
                    </a:r>
                    <a:endParaRPr lang="zh-CN" altLang="en-US" sz="1000" b="1" dirty="0">
                      <a:solidFill>
                        <a:schemeClr val="accent6">
                          <a:lumMod val="75000"/>
                        </a:scheme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4" name="文本框 43">
                    <a:extLst>
                      <a:ext uri="{FF2B5EF4-FFF2-40B4-BE49-F238E27FC236}">
                        <a16:creationId xmlns:a16="http://schemas.microsoft.com/office/drawing/2014/main" id="{31019713-48C5-4D07-8658-9157A571FEA4}"/>
                      </a:ext>
                    </a:extLst>
                  </p:cNvPr>
                  <p:cNvSpPr txBox="1"/>
                  <p:nvPr/>
                </p:nvSpPr>
                <p:spPr>
                  <a:xfrm>
                    <a:off x="1463331" y="3507760"/>
                    <a:ext cx="1560590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endParaRPr lang="en-US" altLang="zh-CN" sz="1000" b="1" dirty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cxnSp>
              <p:nvCxnSpPr>
                <p:cNvPr id="38" name="直接连接符 37">
                  <a:extLst>
                    <a:ext uri="{FF2B5EF4-FFF2-40B4-BE49-F238E27FC236}">
                      <a16:creationId xmlns:a16="http://schemas.microsoft.com/office/drawing/2014/main" id="{90DE11BD-886D-4601-81E0-AA143BBE03D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508510" y="2226950"/>
                  <a:ext cx="288000" cy="0"/>
                </a:xfrm>
                <a:prstGeom prst="line">
                  <a:avLst/>
                </a:prstGeom>
                <a:ln w="38100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9" name="文本框 38">
                  <a:extLst>
                    <a:ext uri="{FF2B5EF4-FFF2-40B4-BE49-F238E27FC236}">
                      <a16:creationId xmlns:a16="http://schemas.microsoft.com/office/drawing/2014/main" id="{B3C5DFD5-D898-4BEB-9ED3-2F69A8D2909B}"/>
                    </a:ext>
                  </a:extLst>
                </p:cNvPr>
                <p:cNvSpPr txBox="1"/>
                <p:nvPr/>
              </p:nvSpPr>
              <p:spPr>
                <a:xfrm>
                  <a:off x="3076972" y="1761482"/>
                  <a:ext cx="34978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  <a:endParaRPr lang="zh-CN" alt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0" name="文本框 39">
                  <a:extLst>
                    <a:ext uri="{FF2B5EF4-FFF2-40B4-BE49-F238E27FC236}">
                      <a16:creationId xmlns:a16="http://schemas.microsoft.com/office/drawing/2014/main" id="{6BB3AE8E-CAF0-4DBE-9C95-BABCF5E3E1AB}"/>
                    </a:ext>
                  </a:extLst>
                </p:cNvPr>
                <p:cNvSpPr txBox="1"/>
                <p:nvPr/>
              </p:nvSpPr>
              <p:spPr>
                <a:xfrm>
                  <a:off x="3413783" y="2224240"/>
                  <a:ext cx="49226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00bp</a:t>
                  </a:r>
                </a:p>
              </p:txBody>
            </p:sp>
          </p:grpSp>
          <p:sp>
            <p:nvSpPr>
              <p:cNvPr id="36" name="矩形 35">
                <a:extLst>
                  <a:ext uri="{FF2B5EF4-FFF2-40B4-BE49-F238E27FC236}">
                    <a16:creationId xmlns:a16="http://schemas.microsoft.com/office/drawing/2014/main" id="{CD8B08E6-7C4D-47C6-953A-2D00774FC41C}"/>
                  </a:ext>
                </a:extLst>
              </p:cNvPr>
              <p:cNvSpPr/>
              <p:nvPr/>
            </p:nvSpPr>
            <p:spPr>
              <a:xfrm>
                <a:off x="6523749" y="3541026"/>
                <a:ext cx="219600" cy="114205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54" name="文本框 53">
              <a:extLst>
                <a:ext uri="{FF2B5EF4-FFF2-40B4-BE49-F238E27FC236}">
                  <a16:creationId xmlns:a16="http://schemas.microsoft.com/office/drawing/2014/main" id="{DDC090B6-A888-4892-A827-5967B14F569D}"/>
                </a:ext>
              </a:extLst>
            </p:cNvPr>
            <p:cNvSpPr txBox="1"/>
            <p:nvPr/>
          </p:nvSpPr>
          <p:spPr>
            <a:xfrm>
              <a:off x="4459531" y="3546790"/>
              <a:ext cx="38639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5" name="组合 24">
              <a:extLst>
                <a:ext uri="{FF2B5EF4-FFF2-40B4-BE49-F238E27FC236}">
                  <a16:creationId xmlns:a16="http://schemas.microsoft.com/office/drawing/2014/main" id="{D9727B5D-F15C-4F5E-BF07-CFF7204C3C4B}"/>
                </a:ext>
              </a:extLst>
            </p:cNvPr>
            <p:cNvGrpSpPr/>
            <p:nvPr/>
          </p:nvGrpSpPr>
          <p:grpSpPr>
            <a:xfrm>
              <a:off x="1411183" y="1491596"/>
              <a:ext cx="5866596" cy="916043"/>
              <a:chOff x="3130687" y="2173170"/>
              <a:chExt cx="5866596" cy="916043"/>
            </a:xfrm>
          </p:grpSpPr>
          <p:grpSp>
            <p:nvGrpSpPr>
              <p:cNvPr id="26" name="组合 25">
                <a:extLst>
                  <a:ext uri="{FF2B5EF4-FFF2-40B4-BE49-F238E27FC236}">
                    <a16:creationId xmlns:a16="http://schemas.microsoft.com/office/drawing/2014/main" id="{9990DBC6-7E7C-46C2-A194-A47AA5C06B20}"/>
                  </a:ext>
                </a:extLst>
              </p:cNvPr>
              <p:cNvGrpSpPr/>
              <p:nvPr/>
            </p:nvGrpSpPr>
            <p:grpSpPr>
              <a:xfrm>
                <a:off x="3130687" y="2173170"/>
                <a:ext cx="5858090" cy="653139"/>
                <a:chOff x="3084038" y="2821778"/>
                <a:chExt cx="5858090" cy="653139"/>
              </a:xfrm>
            </p:grpSpPr>
            <p:sp>
              <p:nvSpPr>
                <p:cNvPr id="64" name="文本框 63">
                  <a:extLst>
                    <a:ext uri="{FF2B5EF4-FFF2-40B4-BE49-F238E27FC236}">
                      <a16:creationId xmlns:a16="http://schemas.microsoft.com/office/drawing/2014/main" id="{35F048DE-BC77-4453-A5E3-768674AD3C0A}"/>
                    </a:ext>
                  </a:extLst>
                </p:cNvPr>
                <p:cNvSpPr txBox="1"/>
                <p:nvPr/>
              </p:nvSpPr>
              <p:spPr>
                <a:xfrm>
                  <a:off x="6181258" y="3080270"/>
                  <a:ext cx="276087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b="1" dirty="0">
                      <a:solidFill>
                        <a:schemeClr val="accent6">
                          <a:lumMod val="75000"/>
                        </a:scheme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ATG                                                            TGA </a:t>
                  </a:r>
                  <a:endParaRPr lang="zh-CN" altLang="en-US" sz="1000" b="1" dirty="0">
                    <a:solidFill>
                      <a:schemeClr val="accent6">
                        <a:lumMod val="7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5" name="文本框 64">
                  <a:extLst>
                    <a:ext uri="{FF2B5EF4-FFF2-40B4-BE49-F238E27FC236}">
                      <a16:creationId xmlns:a16="http://schemas.microsoft.com/office/drawing/2014/main" id="{7B577DE7-3E0B-4107-801E-75D4E37F3AA2}"/>
                    </a:ext>
                  </a:extLst>
                </p:cNvPr>
                <p:cNvSpPr txBox="1"/>
                <p:nvPr/>
              </p:nvSpPr>
              <p:spPr>
                <a:xfrm>
                  <a:off x="3581919" y="2821778"/>
                  <a:ext cx="156059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NP:-2830bp</a:t>
                  </a:r>
                </a:p>
                <a:p>
                  <a:r>
                    <a:rPr lang="en-US" altLang="zh-C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/B/C/D: G/G/G/</a:t>
                  </a:r>
                  <a:r>
                    <a:rPr lang="en-US" altLang="zh-CN" sz="900" b="1" dirty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</a:p>
              </p:txBody>
            </p:sp>
            <p:sp>
              <p:nvSpPr>
                <p:cNvPr id="66" name="文本框 65">
                  <a:extLst>
                    <a:ext uri="{FF2B5EF4-FFF2-40B4-BE49-F238E27FC236}">
                      <a16:creationId xmlns:a16="http://schemas.microsoft.com/office/drawing/2014/main" id="{983B4CB8-0E89-46CB-BF77-416180E14D2B}"/>
                    </a:ext>
                  </a:extLst>
                </p:cNvPr>
                <p:cNvSpPr txBox="1"/>
                <p:nvPr/>
              </p:nvSpPr>
              <p:spPr>
                <a:xfrm>
                  <a:off x="3593941" y="3084233"/>
                  <a:ext cx="27163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</a:t>
                  </a:r>
                  <a:endParaRPr lang="en-US" altLang="zh-CN" sz="1400" b="1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7" name="文本框 66">
                  <a:extLst>
                    <a:ext uri="{FF2B5EF4-FFF2-40B4-BE49-F238E27FC236}">
                      <a16:creationId xmlns:a16="http://schemas.microsoft.com/office/drawing/2014/main" id="{F226E04F-4C6C-4C74-BB55-08803CBB5476}"/>
                    </a:ext>
                  </a:extLst>
                </p:cNvPr>
                <p:cNvSpPr txBox="1"/>
                <p:nvPr/>
              </p:nvSpPr>
              <p:spPr>
                <a:xfrm>
                  <a:off x="3084038" y="3167140"/>
                  <a:ext cx="34978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  <a:endParaRPr lang="zh-CN" alt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27" name="组合 26">
                <a:extLst>
                  <a:ext uri="{FF2B5EF4-FFF2-40B4-BE49-F238E27FC236}">
                    <a16:creationId xmlns:a16="http://schemas.microsoft.com/office/drawing/2014/main" id="{AB99FBD0-9F02-4FD1-BC32-C1397A220CB0}"/>
                  </a:ext>
                </a:extLst>
              </p:cNvPr>
              <p:cNvGrpSpPr/>
              <p:nvPr/>
            </p:nvGrpSpPr>
            <p:grpSpPr>
              <a:xfrm>
                <a:off x="3513225" y="2609378"/>
                <a:ext cx="5484058" cy="479835"/>
                <a:chOff x="3535597" y="2839578"/>
                <a:chExt cx="5484058" cy="479835"/>
              </a:xfrm>
            </p:grpSpPr>
            <p:sp>
              <p:nvSpPr>
                <p:cNvPr id="28" name="箭头: 五边形 27">
                  <a:extLst>
                    <a:ext uri="{FF2B5EF4-FFF2-40B4-BE49-F238E27FC236}">
                      <a16:creationId xmlns:a16="http://schemas.microsoft.com/office/drawing/2014/main" id="{9D49904B-32E6-4107-9AA4-E0DC1083D8BD}"/>
                    </a:ext>
                  </a:extLst>
                </p:cNvPr>
                <p:cNvSpPr/>
                <p:nvPr/>
              </p:nvSpPr>
              <p:spPr>
                <a:xfrm>
                  <a:off x="8681255" y="2839578"/>
                  <a:ext cx="338400" cy="117168"/>
                </a:xfrm>
                <a:prstGeom prst="homePlate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0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" name="矩形 28">
                  <a:extLst>
                    <a:ext uri="{FF2B5EF4-FFF2-40B4-BE49-F238E27FC236}">
                      <a16:creationId xmlns:a16="http://schemas.microsoft.com/office/drawing/2014/main" id="{3953B397-2094-4E95-A8B6-84FFD3D7364A}"/>
                    </a:ext>
                  </a:extLst>
                </p:cNvPr>
                <p:cNvSpPr/>
                <p:nvPr/>
              </p:nvSpPr>
              <p:spPr>
                <a:xfrm>
                  <a:off x="8422055" y="2842855"/>
                  <a:ext cx="259200" cy="113891"/>
                </a:xfrm>
                <a:prstGeom prst="rect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0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30" name="直接连接符 29">
                  <a:extLst>
                    <a:ext uri="{FF2B5EF4-FFF2-40B4-BE49-F238E27FC236}">
                      <a16:creationId xmlns:a16="http://schemas.microsoft.com/office/drawing/2014/main" id="{F0CEBB5C-2382-4661-A11B-FC91DC3846A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240898" y="2901521"/>
                  <a:ext cx="181157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1" name="矩形 30">
                  <a:extLst>
                    <a:ext uri="{FF2B5EF4-FFF2-40B4-BE49-F238E27FC236}">
                      <a16:creationId xmlns:a16="http://schemas.microsoft.com/office/drawing/2014/main" id="{F009B52A-3437-4350-9318-0C761AA33F72}"/>
                    </a:ext>
                  </a:extLst>
                </p:cNvPr>
                <p:cNvSpPr/>
                <p:nvPr/>
              </p:nvSpPr>
              <p:spPr>
                <a:xfrm>
                  <a:off x="8050098" y="2842855"/>
                  <a:ext cx="190800" cy="117168"/>
                </a:xfrm>
                <a:prstGeom prst="rect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0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32" name="直接连接符 31">
                  <a:extLst>
                    <a:ext uri="{FF2B5EF4-FFF2-40B4-BE49-F238E27FC236}">
                      <a16:creationId xmlns:a16="http://schemas.microsoft.com/office/drawing/2014/main" id="{C94A8642-ACE2-441A-A7DE-24BC21AD4C1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467847" y="2900458"/>
                  <a:ext cx="576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5" name="矩形 54">
                  <a:extLst>
                    <a:ext uri="{FF2B5EF4-FFF2-40B4-BE49-F238E27FC236}">
                      <a16:creationId xmlns:a16="http://schemas.microsoft.com/office/drawing/2014/main" id="{E045A70F-0A00-411B-AA54-93E6D7088ADF}"/>
                    </a:ext>
                  </a:extLst>
                </p:cNvPr>
                <p:cNvSpPr/>
                <p:nvPr/>
              </p:nvSpPr>
              <p:spPr>
                <a:xfrm>
                  <a:off x="7111415" y="2841874"/>
                  <a:ext cx="346229" cy="117160"/>
                </a:xfrm>
                <a:prstGeom prst="rect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0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56" name="直接连接符 55">
                  <a:extLst>
                    <a:ext uri="{FF2B5EF4-FFF2-40B4-BE49-F238E27FC236}">
                      <a16:creationId xmlns:a16="http://schemas.microsoft.com/office/drawing/2014/main" id="{21286AC5-0330-43CB-AB89-4B02B9F98C9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806364" y="2900454"/>
                  <a:ext cx="2988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7" name="矩形 56">
                  <a:extLst>
                    <a:ext uri="{FF2B5EF4-FFF2-40B4-BE49-F238E27FC236}">
                      <a16:creationId xmlns:a16="http://schemas.microsoft.com/office/drawing/2014/main" id="{0E40A31C-4199-4805-AA4F-33095FBC086A}"/>
                    </a:ext>
                  </a:extLst>
                </p:cNvPr>
                <p:cNvSpPr/>
                <p:nvPr/>
              </p:nvSpPr>
              <p:spPr>
                <a:xfrm>
                  <a:off x="6498680" y="2841875"/>
                  <a:ext cx="307684" cy="126751"/>
                </a:xfrm>
                <a:prstGeom prst="rect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0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8" name="矩形 57">
                  <a:extLst>
                    <a:ext uri="{FF2B5EF4-FFF2-40B4-BE49-F238E27FC236}">
                      <a16:creationId xmlns:a16="http://schemas.microsoft.com/office/drawing/2014/main" id="{EBBBAD6B-8CC4-4D44-800C-DFBDEE6BF2F7}"/>
                    </a:ext>
                  </a:extLst>
                </p:cNvPr>
                <p:cNvSpPr/>
                <p:nvPr/>
              </p:nvSpPr>
              <p:spPr>
                <a:xfrm>
                  <a:off x="3637727" y="2842855"/>
                  <a:ext cx="2150829" cy="118800"/>
                </a:xfrm>
                <a:prstGeom prst="rect">
                  <a:avLst/>
                </a:prstGeom>
                <a:solidFill>
                  <a:srgbClr val="FFC000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0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59" name="直接连接符 58">
                  <a:extLst>
                    <a:ext uri="{FF2B5EF4-FFF2-40B4-BE49-F238E27FC236}">
                      <a16:creationId xmlns:a16="http://schemas.microsoft.com/office/drawing/2014/main" id="{7161036D-677F-4584-8E68-D750CDA5E6F5}"/>
                    </a:ext>
                  </a:extLst>
                </p:cNvPr>
                <p:cNvCxnSpPr/>
                <p:nvPr/>
              </p:nvCxnSpPr>
              <p:spPr>
                <a:xfrm>
                  <a:off x="3637727" y="3103969"/>
                  <a:ext cx="288000" cy="0"/>
                </a:xfrm>
                <a:prstGeom prst="line">
                  <a:avLst/>
                </a:prstGeom>
                <a:ln w="38100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0" name="文本框 59">
                  <a:extLst>
                    <a:ext uri="{FF2B5EF4-FFF2-40B4-BE49-F238E27FC236}">
                      <a16:creationId xmlns:a16="http://schemas.microsoft.com/office/drawing/2014/main" id="{A3108864-D345-4861-BACA-0D8B80634A2B}"/>
                    </a:ext>
                  </a:extLst>
                </p:cNvPr>
                <p:cNvSpPr txBox="1"/>
                <p:nvPr/>
              </p:nvSpPr>
              <p:spPr>
                <a:xfrm>
                  <a:off x="3535597" y="3103969"/>
                  <a:ext cx="49226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00bp</a:t>
                  </a:r>
                </a:p>
              </p:txBody>
            </p:sp>
            <p:sp>
              <p:nvSpPr>
                <p:cNvPr id="61" name="矩形 60">
                  <a:extLst>
                    <a:ext uri="{FF2B5EF4-FFF2-40B4-BE49-F238E27FC236}">
                      <a16:creationId xmlns:a16="http://schemas.microsoft.com/office/drawing/2014/main" id="{DAE6CF0B-A906-4966-93F3-9F113EAEF647}"/>
                    </a:ext>
                  </a:extLst>
                </p:cNvPr>
                <p:cNvSpPr/>
                <p:nvPr/>
              </p:nvSpPr>
              <p:spPr>
                <a:xfrm>
                  <a:off x="6388028" y="2842854"/>
                  <a:ext cx="119535" cy="125767"/>
                </a:xfrm>
                <a:prstGeom prst="rect">
                  <a:avLst/>
                </a:pr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cxnSp>
              <p:nvCxnSpPr>
                <p:cNvPr id="62" name="直接连接符 61">
                  <a:extLst>
                    <a:ext uri="{FF2B5EF4-FFF2-40B4-BE49-F238E27FC236}">
                      <a16:creationId xmlns:a16="http://schemas.microsoft.com/office/drawing/2014/main" id="{D4F4861B-22E6-4C11-B098-D3850738974E}"/>
                    </a:ext>
                  </a:extLst>
                </p:cNvPr>
                <p:cNvCxnSpPr>
                  <a:cxnSpLocks/>
                  <a:stCxn id="63" idx="3"/>
                  <a:endCxn id="61" idx="1"/>
                </p:cNvCxnSpPr>
                <p:nvPr/>
              </p:nvCxnSpPr>
              <p:spPr>
                <a:xfrm>
                  <a:off x="6137757" y="2902256"/>
                  <a:ext cx="250271" cy="3482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63" name="矩形 62">
                  <a:extLst>
                    <a:ext uri="{FF2B5EF4-FFF2-40B4-BE49-F238E27FC236}">
                      <a16:creationId xmlns:a16="http://schemas.microsoft.com/office/drawing/2014/main" id="{F020E3B3-F39C-4E0C-9A0D-D519036DE0A0}"/>
                    </a:ext>
                  </a:extLst>
                </p:cNvPr>
                <p:cNvSpPr/>
                <p:nvPr/>
              </p:nvSpPr>
              <p:spPr>
                <a:xfrm>
                  <a:off x="5788556" y="2842857"/>
                  <a:ext cx="349201" cy="118798"/>
                </a:xfrm>
                <a:prstGeom prst="rect">
                  <a:avLst/>
                </a:pr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</p:grp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31C121B3-8C87-4358-A59F-AEE4EBFB40B5}"/>
                </a:ext>
              </a:extLst>
            </p:cNvPr>
            <p:cNvSpPr txBox="1"/>
            <p:nvPr/>
          </p:nvSpPr>
          <p:spPr>
            <a:xfrm>
              <a:off x="1359185" y="3568942"/>
              <a:ext cx="34978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2795135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665</TotalTime>
  <Words>437</Words>
  <Application>Microsoft Office PowerPoint</Application>
  <PresentationFormat>全屏显示(4:3)</PresentationFormat>
  <Paragraphs>175</Paragraphs>
  <Slides>7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6" baseType="lpstr">
      <vt:lpstr>等线</vt:lpstr>
      <vt:lpstr>等线 Light</vt:lpstr>
      <vt:lpstr>黑体</vt:lpstr>
      <vt:lpstr>宋体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景光 陈</dc:creator>
  <cp:lastModifiedBy>user</cp:lastModifiedBy>
  <cp:revision>367</cp:revision>
  <dcterms:created xsi:type="dcterms:W3CDTF">2019-03-27T02:33:16Z</dcterms:created>
  <dcterms:modified xsi:type="dcterms:W3CDTF">2023-02-07T13:25:49Z</dcterms:modified>
</cp:coreProperties>
</file>